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media/image12.jpeg" ContentType="image/jpeg"/>
  <Override PartName="/ppt/media/image8.wmf" ContentType="image/x-wmf"/>
  <Override PartName="/ppt/media/image13.png" ContentType="image/png"/>
  <Override PartName="/ppt/media/image9.png" ContentType="image/png"/>
  <Override PartName="/ppt/media/image7.png" ContentType="image/png"/>
  <Override PartName="/ppt/media/image1.jpeg" ContentType="image/jpeg"/>
  <Override PartName="/ppt/media/image11.jpeg" ContentType="image/jpeg"/>
  <Override PartName="/ppt/media/image21.jpeg" ContentType="image/jpeg"/>
  <Override PartName="/ppt/media/image16.png" ContentType="image/png"/>
  <Override PartName="/ppt/media/image20.jpeg" ContentType="image/jpeg"/>
  <Override PartName="/ppt/media/image18.png" ContentType="image/png"/>
  <Override PartName="/ppt/media/image15.jpeg" ContentType="image/jpeg"/>
  <Override PartName="/ppt/media/image19.png" ContentType="image/png"/>
  <Override PartName="/ppt/media/image3.jpeg" ContentType="image/jpeg"/>
  <Override PartName="/ppt/media/image17.jpeg" ContentType="image/jpeg"/>
  <Override PartName="/ppt/media/image14.jpeg" ContentType="image/jpeg"/>
  <Override PartName="/ppt/media/image5.png" ContentType="image/png"/>
  <Override PartName="/ppt/media/image6.jpeg" ContentType="image/jpeg"/>
  <Override PartName="/ppt/media/image10.png" ContentType="image/png"/>
  <Override PartName="/ppt/media/image2.jpeg" ContentType="image/jpeg"/>
  <Override PartName="/ppt/media/image4.jpeg" ContentType="image/jpeg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8.xml.rels" ContentType="application/vnd.openxmlformats-package.relationships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1.xml.rels" ContentType="application/vnd.openxmlformats-package.relationships+xml"/>
  <Override PartName="/ppt/slides/_rels/slide14.xml.rels" ContentType="application/vnd.openxmlformats-package.relationships+xml"/>
  <Override PartName="/ppt/slides/_rels/slide17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</p:sldIdLst>
  <p:sldSz cx="9144000" cy="6858000"/>
  <p:notesSz cx="6781800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A9C7592-5ABA-4D2C-A3D5-5ABB40230206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/>
          </p:nvPr>
        </p:nvSpPr>
        <p:spPr>
          <a:xfrm>
            <a:off x="971640" y="1557000"/>
            <a:ext cx="770400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/>
          </p:nvPr>
        </p:nvSpPr>
        <p:spPr>
          <a:xfrm>
            <a:off x="971640" y="3964320"/>
            <a:ext cx="770400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D2CAFB7-01CC-49CE-B570-27469C5FE19A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971640" y="1557000"/>
            <a:ext cx="37594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919400" y="1557000"/>
            <a:ext cx="37594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/>
          </p:nvPr>
        </p:nvSpPr>
        <p:spPr>
          <a:xfrm>
            <a:off x="971640" y="3964320"/>
            <a:ext cx="37594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31" name="PlaceHolder 5"/>
          <p:cNvSpPr>
            <a:spLocks noGrp="1"/>
          </p:cNvSpPr>
          <p:nvPr>
            <p:ph/>
          </p:nvPr>
        </p:nvSpPr>
        <p:spPr>
          <a:xfrm>
            <a:off x="4919400" y="3964320"/>
            <a:ext cx="37594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2847F59-5930-455C-92CA-3B5A05685633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/>
          </p:nvPr>
        </p:nvSpPr>
        <p:spPr>
          <a:xfrm>
            <a:off x="971640" y="1557000"/>
            <a:ext cx="248040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/>
          </p:nvPr>
        </p:nvSpPr>
        <p:spPr>
          <a:xfrm>
            <a:off x="3576600" y="1557000"/>
            <a:ext cx="248040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/>
          </p:nvPr>
        </p:nvSpPr>
        <p:spPr>
          <a:xfrm>
            <a:off x="6181200" y="1557000"/>
            <a:ext cx="248040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/>
          </p:nvPr>
        </p:nvSpPr>
        <p:spPr>
          <a:xfrm>
            <a:off x="971640" y="3964320"/>
            <a:ext cx="248040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37" name="PlaceHolder 6"/>
          <p:cNvSpPr>
            <a:spLocks noGrp="1"/>
          </p:cNvSpPr>
          <p:nvPr>
            <p:ph/>
          </p:nvPr>
        </p:nvSpPr>
        <p:spPr>
          <a:xfrm>
            <a:off x="3576600" y="3964320"/>
            <a:ext cx="248040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38" name="PlaceHolder 7"/>
          <p:cNvSpPr>
            <a:spLocks noGrp="1"/>
          </p:cNvSpPr>
          <p:nvPr>
            <p:ph/>
          </p:nvPr>
        </p:nvSpPr>
        <p:spPr>
          <a:xfrm>
            <a:off x="6181200" y="3964320"/>
            <a:ext cx="248040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CD1CF85-2F9D-46AB-9C31-E101E7DBC845}" type="slidenum">
              <a:t>&lt;#&gt;</a:t>
            </a:fld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30BA30-90DE-4AE8-A80E-6BB41B3D7ACE}" type="slidenum">
              <a:t>&lt;#&gt;</a:t>
            </a:fld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subTitle"/>
          </p:nvPr>
        </p:nvSpPr>
        <p:spPr>
          <a:xfrm>
            <a:off x="971640" y="1557000"/>
            <a:ext cx="7704000" cy="4608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15DC5B-6AB4-4C90-8708-62EBF963C9A8}" type="slidenum">
              <a:t>&lt;#&gt;</a:t>
            </a:fld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/>
          </p:nvPr>
        </p:nvSpPr>
        <p:spPr>
          <a:xfrm>
            <a:off x="971640" y="1557000"/>
            <a:ext cx="7704000" cy="460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3379F7-22AE-428C-A55B-6751D07E112B}" type="slidenum">
              <a:t>&lt;#&gt;</a:t>
            </a:fld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971640" y="1557000"/>
            <a:ext cx="3759480" cy="460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50" name="PlaceHolder 3"/>
          <p:cNvSpPr>
            <a:spLocks noGrp="1"/>
          </p:cNvSpPr>
          <p:nvPr>
            <p:ph/>
          </p:nvPr>
        </p:nvSpPr>
        <p:spPr>
          <a:xfrm>
            <a:off x="4919400" y="1557000"/>
            <a:ext cx="3759480" cy="460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1F00E2-BDD1-41FB-BA48-202514A44A4A}" type="slidenum">
              <a:t>&lt;#&gt;</a:t>
            </a:fld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D8569B-2907-4128-83E2-831E829B0510}" type="slidenum">
              <a:t>&lt;#&gt;</a:t>
            </a:fld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subTitle"/>
          </p:nvPr>
        </p:nvSpPr>
        <p:spPr>
          <a:xfrm>
            <a:off x="-360" y="188640"/>
            <a:ext cx="8675640" cy="5343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DBBDA0-53B0-49BA-8E9D-3F7D4819B30C}" type="slidenum">
              <a:t>&lt;#&gt;</a:t>
            </a:fld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/>
          </p:nvPr>
        </p:nvSpPr>
        <p:spPr>
          <a:xfrm>
            <a:off x="971640" y="1557000"/>
            <a:ext cx="37594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55" name="PlaceHolder 3"/>
          <p:cNvSpPr>
            <a:spLocks noGrp="1"/>
          </p:cNvSpPr>
          <p:nvPr>
            <p:ph/>
          </p:nvPr>
        </p:nvSpPr>
        <p:spPr>
          <a:xfrm>
            <a:off x="4919400" y="1557000"/>
            <a:ext cx="3759480" cy="460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56" name="PlaceHolder 4"/>
          <p:cNvSpPr>
            <a:spLocks noGrp="1"/>
          </p:cNvSpPr>
          <p:nvPr>
            <p:ph/>
          </p:nvPr>
        </p:nvSpPr>
        <p:spPr>
          <a:xfrm>
            <a:off x="971640" y="3964320"/>
            <a:ext cx="37594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F038B8-6071-4D55-8560-1646763E5C4E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subTitle"/>
          </p:nvPr>
        </p:nvSpPr>
        <p:spPr>
          <a:xfrm>
            <a:off x="971640" y="1557000"/>
            <a:ext cx="7704000" cy="4608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CDA9126-7DF5-4298-917C-517E780C5219}" type="slidenum">
              <a:t>&lt;#&gt;</a:t>
            </a:fld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/>
          </p:nvPr>
        </p:nvSpPr>
        <p:spPr>
          <a:xfrm>
            <a:off x="971640" y="1557000"/>
            <a:ext cx="3759480" cy="460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/>
          </p:nvPr>
        </p:nvSpPr>
        <p:spPr>
          <a:xfrm>
            <a:off x="4919400" y="1557000"/>
            <a:ext cx="37594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60" name="PlaceHolder 4"/>
          <p:cNvSpPr>
            <a:spLocks noGrp="1"/>
          </p:cNvSpPr>
          <p:nvPr>
            <p:ph/>
          </p:nvPr>
        </p:nvSpPr>
        <p:spPr>
          <a:xfrm>
            <a:off x="4919400" y="3964320"/>
            <a:ext cx="37594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3DA72E-5F61-44DF-A65E-937DDC942527}" type="slidenum">
              <a:t>&lt;#&gt;</a:t>
            </a:fld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/>
          </p:nvPr>
        </p:nvSpPr>
        <p:spPr>
          <a:xfrm>
            <a:off x="971640" y="1557000"/>
            <a:ext cx="37594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/>
          </p:nvPr>
        </p:nvSpPr>
        <p:spPr>
          <a:xfrm>
            <a:off x="4919400" y="1557000"/>
            <a:ext cx="37594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64" name="PlaceHolder 4"/>
          <p:cNvSpPr>
            <a:spLocks noGrp="1"/>
          </p:cNvSpPr>
          <p:nvPr>
            <p:ph/>
          </p:nvPr>
        </p:nvSpPr>
        <p:spPr>
          <a:xfrm>
            <a:off x="971640" y="3964320"/>
            <a:ext cx="770400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6F0383-D37C-4CC8-94F2-D5FF4070F0F6}" type="slidenum">
              <a:t>&lt;#&gt;</a:t>
            </a:fld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/>
          </p:nvPr>
        </p:nvSpPr>
        <p:spPr>
          <a:xfrm>
            <a:off x="971640" y="1557000"/>
            <a:ext cx="770400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67" name="PlaceHolder 3"/>
          <p:cNvSpPr>
            <a:spLocks noGrp="1"/>
          </p:cNvSpPr>
          <p:nvPr>
            <p:ph/>
          </p:nvPr>
        </p:nvSpPr>
        <p:spPr>
          <a:xfrm>
            <a:off x="971640" y="3964320"/>
            <a:ext cx="770400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6BCD86-E9A9-403D-A431-1FE2076E67AC}" type="slidenum">
              <a:t>&lt;#&gt;</a:t>
            </a:fld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/>
          </p:nvPr>
        </p:nvSpPr>
        <p:spPr>
          <a:xfrm>
            <a:off x="971640" y="1557000"/>
            <a:ext cx="37594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/>
          </p:nvPr>
        </p:nvSpPr>
        <p:spPr>
          <a:xfrm>
            <a:off x="4919400" y="1557000"/>
            <a:ext cx="37594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71" name="PlaceHolder 4"/>
          <p:cNvSpPr>
            <a:spLocks noGrp="1"/>
          </p:cNvSpPr>
          <p:nvPr>
            <p:ph/>
          </p:nvPr>
        </p:nvSpPr>
        <p:spPr>
          <a:xfrm>
            <a:off x="971640" y="3964320"/>
            <a:ext cx="37594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72" name="PlaceHolder 5"/>
          <p:cNvSpPr>
            <a:spLocks noGrp="1"/>
          </p:cNvSpPr>
          <p:nvPr>
            <p:ph/>
          </p:nvPr>
        </p:nvSpPr>
        <p:spPr>
          <a:xfrm>
            <a:off x="4919400" y="3964320"/>
            <a:ext cx="37594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86C8BA-A6CC-446E-96B4-E0127B2EC8BB}" type="slidenum">
              <a:t>&lt;#&gt;</a:t>
            </a:fld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74" name="PlaceHolder 2"/>
          <p:cNvSpPr>
            <a:spLocks noGrp="1"/>
          </p:cNvSpPr>
          <p:nvPr>
            <p:ph/>
          </p:nvPr>
        </p:nvSpPr>
        <p:spPr>
          <a:xfrm>
            <a:off x="971640" y="1557000"/>
            <a:ext cx="248040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75" name="PlaceHolder 3"/>
          <p:cNvSpPr>
            <a:spLocks noGrp="1"/>
          </p:cNvSpPr>
          <p:nvPr>
            <p:ph/>
          </p:nvPr>
        </p:nvSpPr>
        <p:spPr>
          <a:xfrm>
            <a:off x="3576600" y="1557000"/>
            <a:ext cx="248040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76" name="PlaceHolder 4"/>
          <p:cNvSpPr>
            <a:spLocks noGrp="1"/>
          </p:cNvSpPr>
          <p:nvPr>
            <p:ph/>
          </p:nvPr>
        </p:nvSpPr>
        <p:spPr>
          <a:xfrm>
            <a:off x="6181200" y="1557000"/>
            <a:ext cx="248040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77" name="PlaceHolder 5"/>
          <p:cNvSpPr>
            <a:spLocks noGrp="1"/>
          </p:cNvSpPr>
          <p:nvPr>
            <p:ph/>
          </p:nvPr>
        </p:nvSpPr>
        <p:spPr>
          <a:xfrm>
            <a:off x="971640" y="3964320"/>
            <a:ext cx="248040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78" name="PlaceHolder 6"/>
          <p:cNvSpPr>
            <a:spLocks noGrp="1"/>
          </p:cNvSpPr>
          <p:nvPr>
            <p:ph/>
          </p:nvPr>
        </p:nvSpPr>
        <p:spPr>
          <a:xfrm>
            <a:off x="3576600" y="3964320"/>
            <a:ext cx="248040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79" name="PlaceHolder 7"/>
          <p:cNvSpPr>
            <a:spLocks noGrp="1"/>
          </p:cNvSpPr>
          <p:nvPr>
            <p:ph/>
          </p:nvPr>
        </p:nvSpPr>
        <p:spPr>
          <a:xfrm>
            <a:off x="6181200" y="3964320"/>
            <a:ext cx="248040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62BE4C-9FD7-4C62-BE71-341FC457BCD2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/>
          </p:nvPr>
        </p:nvSpPr>
        <p:spPr>
          <a:xfrm>
            <a:off x="971640" y="1557000"/>
            <a:ext cx="7704000" cy="460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CC1FBD7-D8BF-43D6-A63D-365C96FA0AF2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971640" y="1557000"/>
            <a:ext cx="3759480" cy="460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9" name="PlaceHolder 3"/>
          <p:cNvSpPr>
            <a:spLocks noGrp="1"/>
          </p:cNvSpPr>
          <p:nvPr>
            <p:ph/>
          </p:nvPr>
        </p:nvSpPr>
        <p:spPr>
          <a:xfrm>
            <a:off x="4919400" y="1557000"/>
            <a:ext cx="3759480" cy="460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754114F-7543-4744-BAF6-8A5C9EF4A6BC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E83E6D7-04F9-4B8B-ABA8-F093A3244CCE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subTitle"/>
          </p:nvPr>
        </p:nvSpPr>
        <p:spPr>
          <a:xfrm>
            <a:off x="-360" y="188640"/>
            <a:ext cx="8675640" cy="5343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F0B4C5A4-899C-42FA-9266-F54901298F0D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/>
          </p:nvPr>
        </p:nvSpPr>
        <p:spPr>
          <a:xfrm>
            <a:off x="971640" y="1557000"/>
            <a:ext cx="37594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/>
          </p:nvPr>
        </p:nvSpPr>
        <p:spPr>
          <a:xfrm>
            <a:off x="4919400" y="1557000"/>
            <a:ext cx="3759480" cy="460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15" name="PlaceHolder 4"/>
          <p:cNvSpPr>
            <a:spLocks noGrp="1"/>
          </p:cNvSpPr>
          <p:nvPr>
            <p:ph/>
          </p:nvPr>
        </p:nvSpPr>
        <p:spPr>
          <a:xfrm>
            <a:off x="971640" y="3964320"/>
            <a:ext cx="37594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5B23F80D-5582-4D93-8949-2D0DD71D741D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/>
          </p:nvPr>
        </p:nvSpPr>
        <p:spPr>
          <a:xfrm>
            <a:off x="971640" y="1557000"/>
            <a:ext cx="3759480" cy="460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/>
          </p:nvPr>
        </p:nvSpPr>
        <p:spPr>
          <a:xfrm>
            <a:off x="4919400" y="1557000"/>
            <a:ext cx="37594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/>
          </p:nvPr>
        </p:nvSpPr>
        <p:spPr>
          <a:xfrm>
            <a:off x="4919400" y="3964320"/>
            <a:ext cx="37594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A9C3120-3FDF-4D3E-95C4-2673309EFBA9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/>
          </p:nvPr>
        </p:nvSpPr>
        <p:spPr>
          <a:xfrm>
            <a:off x="971640" y="1557000"/>
            <a:ext cx="37594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/>
          </p:nvPr>
        </p:nvSpPr>
        <p:spPr>
          <a:xfrm>
            <a:off x="4919400" y="1557000"/>
            <a:ext cx="375948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/>
          </p:nvPr>
        </p:nvSpPr>
        <p:spPr>
          <a:xfrm>
            <a:off x="971640" y="3964320"/>
            <a:ext cx="7704000" cy="2198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AA520A8-225C-4B35-AA0C-470A3DD555C5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jpeg"/><Relationship Id="rId3" Type="http://schemas.openxmlformats.org/officeDocument/2006/relationships/slideLayout" Target="../slideLayouts/slideLayout1.xml"/><Relationship Id="rId4" Type="http://schemas.openxmlformats.org/officeDocument/2006/relationships/slideLayout" Target="../slideLayouts/slideLayout2.xml"/><Relationship Id="rId5" Type="http://schemas.openxmlformats.org/officeDocument/2006/relationships/slideLayout" Target="../slideLayouts/slideLayout3.xml"/><Relationship Id="rId6" Type="http://schemas.openxmlformats.org/officeDocument/2006/relationships/slideLayout" Target="../slideLayouts/slideLayout4.xml"/><Relationship Id="rId7" Type="http://schemas.openxmlformats.org/officeDocument/2006/relationships/slideLayout" Target="../slideLayouts/slideLayout5.xml"/><Relationship Id="rId8" Type="http://schemas.openxmlformats.org/officeDocument/2006/relationships/slideLayout" Target="../slideLayouts/slideLayout6.xml"/><Relationship Id="rId9" Type="http://schemas.openxmlformats.org/officeDocument/2006/relationships/slideLayout" Target="../slideLayouts/slideLayout7.xml"/><Relationship Id="rId10" Type="http://schemas.openxmlformats.org/officeDocument/2006/relationships/slideLayout" Target="../slideLayouts/slideLayout8.xml"/><Relationship Id="rId11" Type="http://schemas.openxmlformats.org/officeDocument/2006/relationships/slideLayout" Target="../slideLayouts/slideLayout9.xml"/><Relationship Id="rId12" Type="http://schemas.openxmlformats.org/officeDocument/2006/relationships/slideLayout" Target="../slideLayouts/slideLayout10.xml"/><Relationship Id="rId13" Type="http://schemas.openxmlformats.org/officeDocument/2006/relationships/slideLayout" Target="../slideLayouts/slideLayout11.xml"/><Relationship Id="rId14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3.xml"/><Relationship Id="rId5" Type="http://schemas.openxmlformats.org/officeDocument/2006/relationships/slideLayout" Target="../slideLayouts/slideLayout14.xml"/><Relationship Id="rId6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6.xml"/><Relationship Id="rId8" Type="http://schemas.openxmlformats.org/officeDocument/2006/relationships/slideLayout" Target="../slideLayouts/slideLayout17.xml"/><Relationship Id="rId9" Type="http://schemas.openxmlformats.org/officeDocument/2006/relationships/slideLayout" Target="../slideLayouts/slideLayout18.xml"/><Relationship Id="rId10" Type="http://schemas.openxmlformats.org/officeDocument/2006/relationships/slideLayout" Target="../slideLayouts/slideLayout19.xml"/><Relationship Id="rId11" Type="http://schemas.openxmlformats.org/officeDocument/2006/relationships/slideLayout" Target="../slideLayouts/slideLayout20.xml"/><Relationship Id="rId12" Type="http://schemas.openxmlformats.org/officeDocument/2006/relationships/slideLayout" Target="../slideLayouts/slideLayout21.xml"/><Relationship Id="rId13" Type="http://schemas.openxmlformats.org/officeDocument/2006/relationships/slideLayout" Target="../slideLayouts/slideLayout22.xml"/><Relationship Id="rId14" Type="http://schemas.openxmlformats.org/officeDocument/2006/relationships/slideLayout" Target="../slideLayouts/slideLayout23.xml"/><Relationship Id="rId15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2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da0000"/>
                </a:solidFill>
                <a:latin typeface="Arial"/>
              </a:rPr>
              <a:t>Click to edit the title text format</a:t>
            </a: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971640" y="1557000"/>
            <a:ext cx="7704000" cy="460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Click to edit the outline text format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1" marL="622440" indent="-184320">
              <a:spcBef>
                <a:spcPts val="400"/>
              </a:spcBef>
              <a:buClr>
                <a:srgbClr val="4d4d4d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Second Outline Level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2" marL="987480" indent="-185760">
              <a:spcBef>
                <a:spcPts val="400"/>
              </a:spcBef>
              <a:buClr>
                <a:srgbClr val="4d4d4d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Third Outline Level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3" marL="1434960" indent="-176040">
              <a:spcBef>
                <a:spcPts val="400"/>
              </a:spcBef>
              <a:buClr>
                <a:srgbClr val="4d4d4d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Fourth Outline Level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4" marL="1790640" indent="-176040">
              <a:spcBef>
                <a:spcPts val="400"/>
              </a:spcBef>
              <a:buClr>
                <a:srgbClr val="4d4d4d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Fifth Outline Level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5" marL="1790640" indent="-176040">
              <a:spcBef>
                <a:spcPts val="400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Sixth Outline Level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6" marL="1790640" indent="-176040">
              <a:spcBef>
                <a:spcPts val="400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Seventh Outline Level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 idx="1"/>
          </p:nvPr>
        </p:nvSpPr>
        <p:spPr>
          <a:xfrm>
            <a:off x="34920" y="0"/>
            <a:ext cx="1008000" cy="404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800" spc="-1" strike="noStrike">
                <a:solidFill>
                  <a:srgbClr val="9c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9c0000"/>
                </a:solidFill>
                <a:latin typeface="Arial"/>
              </a:rPr>
              <a:t>0</a:t>
            </a:r>
            <a:fld id="{9D4BEBF6-33C9-4951-9046-D357E7E125E4}" type="slidenum">
              <a:rPr b="0" lang="es-ES" sz="1800" spc="-1" strike="noStrike">
                <a:solidFill>
                  <a:srgbClr val="9c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3"/>
    <p:sldLayoutId id="2147483650" r:id="rId4"/>
    <p:sldLayoutId id="2147483651" r:id="rId5"/>
    <p:sldLayoutId id="2147483652" r:id="rId6"/>
    <p:sldLayoutId id="2147483653" r:id="rId7"/>
    <p:sldLayoutId id="2147483654" r:id="rId8"/>
    <p:sldLayoutId id="2147483655" r:id="rId9"/>
    <p:sldLayoutId id="2147483656" r:id="rId10"/>
    <p:sldLayoutId id="2147483657" r:id="rId11"/>
    <p:sldLayoutId id="2147483658" r:id="rId12"/>
    <p:sldLayoutId id="2147483659" r:id="rId13"/>
    <p:sldLayoutId id="2147483660" r:id="rId14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2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Picture 8" descr="logo-UPV"/>
          <p:cNvPicPr/>
          <p:nvPr/>
        </p:nvPicPr>
        <p:blipFill>
          <a:blip r:embed="rId3"/>
          <a:stretch/>
        </p:blipFill>
        <p:spPr>
          <a:xfrm>
            <a:off x="250920" y="6218280"/>
            <a:ext cx="1657080" cy="615960"/>
          </a:xfrm>
          <a:prstGeom prst="rect">
            <a:avLst/>
          </a:prstGeom>
          <a:ln w="0">
            <a:noFill/>
          </a:ln>
        </p:spPr>
      </p:pic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da0000"/>
                </a:solidFill>
                <a:latin typeface="Arial"/>
              </a:rPr>
              <a:t>Click to edit the title text format</a:t>
            </a: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 type="body"/>
          </p:nvPr>
        </p:nvSpPr>
        <p:spPr>
          <a:xfrm>
            <a:off x="971640" y="1557000"/>
            <a:ext cx="7704000" cy="460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Click to edit the outline text format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1" marL="622440" indent="-184320">
              <a:spcBef>
                <a:spcPts val="400"/>
              </a:spcBef>
              <a:buClr>
                <a:srgbClr val="4d4d4d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Second Outline Level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2" marL="987480" indent="-185760">
              <a:spcBef>
                <a:spcPts val="400"/>
              </a:spcBef>
              <a:buClr>
                <a:srgbClr val="4d4d4d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Third Outline Level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3" marL="1434960" indent="-176040">
              <a:spcBef>
                <a:spcPts val="400"/>
              </a:spcBef>
              <a:buClr>
                <a:srgbClr val="4d4d4d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Fourth Outline Level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4" marL="1790640" indent="-176040">
              <a:spcBef>
                <a:spcPts val="400"/>
              </a:spcBef>
              <a:buClr>
                <a:srgbClr val="4d4d4d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Fifth Outline Level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5" marL="1790640" indent="-176040">
              <a:spcBef>
                <a:spcPts val="400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Sixth Outline Level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6" marL="1790640" indent="-176040">
              <a:spcBef>
                <a:spcPts val="400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Seventh Outline Level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42" name="PlaceHolder 3"/>
          <p:cNvSpPr>
            <a:spLocks noGrp="1"/>
          </p:cNvSpPr>
          <p:nvPr>
            <p:ph type="ftr" idx="2"/>
          </p:nvPr>
        </p:nvSpPr>
        <p:spPr>
          <a:xfrm>
            <a:off x="466560" y="547560"/>
            <a:ext cx="6337440" cy="144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900" spc="-1" strike="noStrike">
                <a:solidFill>
                  <a:srgbClr val="ffffff"/>
                </a:solidFill>
                <a:latin typeface="Verdana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ffffff"/>
                </a:solidFill>
                <a:latin typeface="Verdana"/>
              </a:rPr>
              <a:t>TITULO DE LA PRESENTACIÓN - Motivo de la presentació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4"/>
          <p:cNvSpPr>
            <a:spLocks noGrp="1"/>
          </p:cNvSpPr>
          <p:nvPr>
            <p:ph type="sldNum" idx="3"/>
          </p:nvPr>
        </p:nvSpPr>
        <p:spPr>
          <a:xfrm>
            <a:off x="7009920" y="-171720"/>
            <a:ext cx="2133720" cy="664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6600" spc="-1" strike="noStrike">
                <a:solidFill>
                  <a:srgbClr val="4d4d4d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6600" spc="-1" strike="noStrike">
                <a:solidFill>
                  <a:srgbClr val="4d4d4d"/>
                </a:solidFill>
                <a:latin typeface="Arial"/>
              </a:rPr>
              <a:t>0</a:t>
            </a:r>
            <a:fld id="{16330D71-B056-42AC-9D4C-C0025736D5BB}" type="slidenum">
              <a:rPr b="0" lang="es-ES" sz="6600" spc="-1" strike="noStrike">
                <a:solidFill>
                  <a:srgbClr val="4d4d4d"/>
                </a:solidFill>
                <a:latin typeface="Arial"/>
              </a:rPr>
              <a:t>&lt;number&gt;</a:t>
            </a:fld>
            <a:endParaRPr b="0" lang="en-US" sz="6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4"/>
    <p:sldLayoutId id="2147483663" r:id="rId5"/>
    <p:sldLayoutId id="2147483664" r:id="rId6"/>
    <p:sldLayoutId id="2147483665" r:id="rId7"/>
    <p:sldLayoutId id="2147483666" r:id="rId8"/>
    <p:sldLayoutId id="2147483667" r:id="rId9"/>
    <p:sldLayoutId id="2147483668" r:id="rId10"/>
    <p:sldLayoutId id="2147483669" r:id="rId11"/>
    <p:sldLayoutId id="2147483670" r:id="rId12"/>
    <p:sldLayoutId id="2147483671" r:id="rId13"/>
    <p:sldLayoutId id="2147483672" r:id="rId14"/>
    <p:sldLayoutId id="2147483673" r:id="rId15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18.png"/><Relationship Id="rId3" Type="http://schemas.openxmlformats.org/officeDocument/2006/relationships/image" Target="../media/image11.jpeg"/><Relationship Id="rId4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19.png"/><Relationship Id="rId3" Type="http://schemas.openxmlformats.org/officeDocument/2006/relationships/image" Target="../media/image20.jpeg"/><Relationship Id="rId4" Type="http://schemas.openxmlformats.org/officeDocument/2006/relationships/image" Target="../media/image21.jpeg"/><Relationship Id="rId5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19.png"/><Relationship Id="rId3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20.jpeg"/><Relationship Id="rId3" Type="http://schemas.openxmlformats.org/officeDocument/2006/relationships/image" Target="../media/image21.jpeg"/><Relationship Id="rId4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hyperlink" Target="mailto:mclemente@labhuman.i3bh.es" TargetMode="External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image" Target="../media/image7.png"/><Relationship Id="rId3" Type="http://schemas.openxmlformats.org/officeDocument/2006/relationships/image" Target="../media/image8.wmf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7.png"/><Relationship Id="rId4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11.jpe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12.jpeg"/><Relationship Id="rId3" Type="http://schemas.openxmlformats.org/officeDocument/2006/relationships/image" Target="../media/image13.png"/><Relationship Id="rId4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14.jpeg"/><Relationship Id="rId3" Type="http://schemas.openxmlformats.org/officeDocument/2006/relationships/image" Target="../media/image15.jpeg"/><Relationship Id="rId4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16.png"/><Relationship Id="rId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17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marL="990720" indent="-990720">
              <a:lnSpc>
                <a:spcPct val="80000"/>
              </a:lnSpc>
              <a:buSzPct val="154331"/>
              <a:buBlip>
                <a:blip r:embed="rId1"/>
              </a:buBlip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3600" spc="-1" strike="noStrike">
                <a:solidFill>
                  <a:srgbClr val="da0000"/>
                </a:solidFill>
                <a:latin typeface="Arial"/>
              </a:rPr>
              <a:t>ENVIRONMENTS</a:t>
            </a: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119" name=""/>
          <p:cNvSpPr txBox="1"/>
          <p:nvPr/>
        </p:nvSpPr>
        <p:spPr>
          <a:xfrm>
            <a:off x="285480" y="1557000"/>
            <a:ext cx="8389800" cy="4608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176040" indent="-1760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Different experimental conditions will be applied in a repetitive and counterbalanced way: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A clean room without spiders or cockroaches;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The same room, but dirty and disordered (giving the sensation that small animals can appear)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c00000"/>
                </a:solidFill>
                <a:latin typeface="Arial"/>
              </a:rPr>
              <a:t>The same dirty room but with spiders and cockroaches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120" name="3 Marcador de número de diapositiva"/>
          <p:cNvSpPr/>
          <p:nvPr/>
        </p:nvSpPr>
        <p:spPr>
          <a:xfrm>
            <a:off x="34920" y="0"/>
            <a:ext cx="1008000" cy="40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9c0000"/>
                </a:solidFill>
                <a:latin typeface="Arial"/>
              </a:rPr>
              <a:t>0</a:t>
            </a:r>
            <a:fld id="{1B51D2D1-DBFA-4CA2-AEB1-708D0237A909}" type="slidenum">
              <a:rPr b="0" lang="es-ES" sz="1800" spc="-1" strike="noStrike">
                <a:solidFill>
                  <a:srgbClr val="9c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1" name="4 Imagen" descr="CLEMENTE_M_Fig2.tif"/>
          <p:cNvPicPr/>
          <p:nvPr/>
        </p:nvPicPr>
        <p:blipFill>
          <a:blip r:embed="rId2"/>
          <a:stretch/>
        </p:blipFill>
        <p:spPr>
          <a:xfrm>
            <a:off x="1000080" y="3143160"/>
            <a:ext cx="4286160" cy="3214800"/>
          </a:xfrm>
          <a:prstGeom prst="rect">
            <a:avLst/>
          </a:prstGeom>
          <a:ln w="0">
            <a:noFill/>
          </a:ln>
        </p:spPr>
      </p:pic>
      <p:pic>
        <p:nvPicPr>
          <p:cNvPr id="122" name="5 Imagen" descr="CLEMENTE_M_Fig3.tif"/>
          <p:cNvPicPr/>
          <p:nvPr/>
        </p:nvPicPr>
        <p:blipFill>
          <a:blip r:embed="rId3"/>
          <a:stretch/>
        </p:blipFill>
        <p:spPr>
          <a:xfrm>
            <a:off x="5929200" y="4000680"/>
            <a:ext cx="1809720" cy="1514160"/>
          </a:xfrm>
          <a:prstGeom prst="rect">
            <a:avLst/>
          </a:prstGeom>
          <a:ln w="0">
            <a:noFill/>
          </a:ln>
        </p:spPr>
      </p:pic>
      <p:sp>
        <p:nvSpPr>
          <p:cNvPr id="123" name="6 CuadroTexto"/>
          <p:cNvSpPr/>
          <p:nvPr/>
        </p:nvSpPr>
        <p:spPr>
          <a:xfrm>
            <a:off x="6084720" y="3284640"/>
            <a:ext cx="136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ff0000"/>
                </a:solidFill>
                <a:latin typeface="Arial"/>
              </a:rPr>
              <a:t>“</a:t>
            </a:r>
            <a:r>
              <a:rPr b="1" lang="es-ES" sz="1800" spc="-1" strike="noStrike">
                <a:solidFill>
                  <a:srgbClr val="ff0000"/>
                </a:solidFill>
                <a:latin typeface="Arial"/>
              </a:rPr>
              <a:t>PHOBIC”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marL="990720" indent="-990720">
              <a:lnSpc>
                <a:spcPct val="80000"/>
              </a:lnSpc>
              <a:buSzPct val="154331"/>
              <a:buBlip>
                <a:blip r:embed="rId1"/>
              </a:buBlip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3600" spc="-1" strike="noStrike">
                <a:solidFill>
                  <a:srgbClr val="da0000"/>
                </a:solidFill>
                <a:latin typeface="Arial"/>
              </a:rPr>
              <a:t>DATA ANALYSIS</a:t>
            </a: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125" name=""/>
          <p:cNvSpPr txBox="1"/>
          <p:nvPr/>
        </p:nvSpPr>
        <p:spPr>
          <a:xfrm>
            <a:off x="971640" y="1557000"/>
            <a:ext cx="7704000" cy="4608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We have used the Statistical Parametric Mapping software (SPM8) for the analysis of the fMRI data, launched with the 7.1 version of Matlab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Preprocessing of the data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Fixed-effect first level analysis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Group tests at a second level random effect analysis </a:t>
            </a:r>
            <a:r>
              <a:rPr b="0" lang="en-US" sz="1600" spc="-1" strike="noStrike">
                <a:solidFill>
                  <a:srgbClr val="4d4d4d"/>
                </a:solidFill>
                <a:latin typeface="Wingdings"/>
                <a:ea typeface="Wingdings"/>
              </a:rPr>
              <a:t>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one-sample t-test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We obtained three contrasts: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1" marL="622440" indent="-184320">
              <a:spcBef>
                <a:spcPts val="400"/>
              </a:spcBef>
              <a:buClr>
                <a:srgbClr val="4d4d4d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“</a:t>
            </a: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phobic&gt;clean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” contrast </a:t>
            </a:r>
            <a:r>
              <a:rPr b="0" lang="en-US" sz="1600" spc="-1" strike="noStrike">
                <a:solidFill>
                  <a:srgbClr val="4d4d4d"/>
                </a:solidFill>
                <a:latin typeface="Wingdings"/>
                <a:ea typeface="Wingdings"/>
              </a:rPr>
              <a:t>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contains the results that show the brain activations for the phobic stimulus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1" marL="622440" indent="-184320">
              <a:spcBef>
                <a:spcPts val="400"/>
              </a:spcBef>
              <a:buClr>
                <a:srgbClr val="4d4d4d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“</a:t>
            </a: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phobic&gt;dirty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” contrast </a:t>
            </a:r>
            <a:r>
              <a:rPr b="0" lang="en-US" sz="1600" spc="-1" strike="noStrike">
                <a:solidFill>
                  <a:srgbClr val="4d4d4d"/>
                </a:solidFill>
                <a:latin typeface="Wingdings"/>
                <a:ea typeface="Wingdings"/>
              </a:rPr>
              <a:t>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shows phobic activations avoiding the anxiety feeling caused by the dirtiness of the room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1" marL="622440" indent="-184320">
              <a:spcBef>
                <a:spcPts val="400"/>
              </a:spcBef>
              <a:buClr>
                <a:srgbClr val="4d4d4d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“</a:t>
            </a: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dirty&gt;clean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” contrast </a:t>
            </a:r>
            <a:r>
              <a:rPr b="0" lang="en-US" sz="1600" spc="-1" strike="noStrike">
                <a:solidFill>
                  <a:srgbClr val="4d4d4d"/>
                </a:solidFill>
                <a:latin typeface="Wingdings"/>
                <a:ea typeface="Wingdings"/>
              </a:rPr>
              <a:t>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contains the anxiety related activations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All contrasts at group level were considered if more than 10 adjacent voxels passed the statistical threshold of p &lt; 0.005 (uncorrected)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These results were corrected at p&lt;0.05 using AlphaSim correction (combined height threshold p&lt;0.005 and a minimum cluster size= 25)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126" name="3 Marcador de número de diapositiva"/>
          <p:cNvSpPr/>
          <p:nvPr/>
        </p:nvSpPr>
        <p:spPr>
          <a:xfrm>
            <a:off x="34920" y="0"/>
            <a:ext cx="1008000" cy="40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9c0000"/>
                </a:solidFill>
                <a:latin typeface="Arial"/>
              </a:rPr>
              <a:t>0</a:t>
            </a:r>
            <a:fld id="{93603E8C-CE80-442D-BD4D-1551499C4A8B}" type="slidenum">
              <a:rPr b="0" lang="es-ES" sz="1800" spc="-1" strike="noStrike">
                <a:solidFill>
                  <a:srgbClr val="9c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marL="990720" indent="-990720">
              <a:lnSpc>
                <a:spcPct val="80000"/>
              </a:lnSpc>
              <a:buSzPct val="154331"/>
              <a:buBlip>
                <a:blip r:embed="rId1"/>
              </a:buBlip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3600" spc="-1" strike="noStrike">
                <a:solidFill>
                  <a:srgbClr val="da0000"/>
                </a:solidFill>
                <a:latin typeface="Arial"/>
              </a:rPr>
              <a:t>RESULTS</a:t>
            </a: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128" name=""/>
          <p:cNvSpPr txBox="1"/>
          <p:nvPr/>
        </p:nvSpPr>
        <p:spPr>
          <a:xfrm>
            <a:off x="428760" y="1557000"/>
            <a:ext cx="8246880" cy="4608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“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phobic &gt; clean” contrast:  left occipital inferior lobe, middle occipital gyrus bilaterally, cuneus bilaterally, superior frontal gyrus and precuneus.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“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phobic &gt; dirty” contrast: inferior occipital lobe bilaterally, left superior and middle frontal lobe.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“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dirty &gt; clean” contrast: left superior occipital lobe, right middle frontal gyrus, middle occipital gyrus and cingulate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129" name="3 Marcador de número de diapositiva"/>
          <p:cNvSpPr/>
          <p:nvPr/>
        </p:nvSpPr>
        <p:spPr>
          <a:xfrm>
            <a:off x="34920" y="0"/>
            <a:ext cx="1008000" cy="40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9c0000"/>
                </a:solidFill>
                <a:latin typeface="Arial"/>
              </a:rPr>
              <a:t>0</a:t>
            </a:r>
            <a:fld id="{40EB51AB-756D-452E-8D0F-A054DC8CC225}" type="slidenum">
              <a:rPr b="0" lang="es-ES" sz="1800" spc="-1" strike="noStrike">
                <a:solidFill>
                  <a:srgbClr val="9c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0" name="Picture 6" descr=""/>
          <p:cNvPicPr/>
          <p:nvPr/>
        </p:nvPicPr>
        <p:blipFill>
          <a:blip r:embed="rId2"/>
          <a:srcRect l="4169" t="1711" r="5452" b="4103"/>
          <a:stretch/>
        </p:blipFill>
        <p:spPr>
          <a:xfrm>
            <a:off x="324000" y="3284640"/>
            <a:ext cx="2447640" cy="2241360"/>
          </a:xfrm>
          <a:prstGeom prst="rect">
            <a:avLst/>
          </a:prstGeom>
          <a:ln w="0">
            <a:noFill/>
          </a:ln>
        </p:spPr>
      </p:pic>
      <p:pic>
        <p:nvPicPr>
          <p:cNvPr id="131" name="Picture 7" descr=""/>
          <p:cNvPicPr/>
          <p:nvPr/>
        </p:nvPicPr>
        <p:blipFill>
          <a:blip r:embed="rId3"/>
          <a:stretch/>
        </p:blipFill>
        <p:spPr>
          <a:xfrm>
            <a:off x="3203640" y="3284640"/>
            <a:ext cx="2440080" cy="2232000"/>
          </a:xfrm>
          <a:prstGeom prst="rect">
            <a:avLst/>
          </a:prstGeom>
          <a:ln w="0">
            <a:noFill/>
          </a:ln>
        </p:spPr>
      </p:pic>
      <p:pic>
        <p:nvPicPr>
          <p:cNvPr id="132" name="Picture 8" descr=""/>
          <p:cNvPicPr/>
          <p:nvPr/>
        </p:nvPicPr>
        <p:blipFill>
          <a:blip r:embed="rId4"/>
          <a:stretch/>
        </p:blipFill>
        <p:spPr>
          <a:xfrm>
            <a:off x="6084720" y="3284640"/>
            <a:ext cx="2462400" cy="2232000"/>
          </a:xfrm>
          <a:prstGeom prst="rect">
            <a:avLst/>
          </a:prstGeom>
          <a:ln w="0">
            <a:noFill/>
          </a:ln>
        </p:spPr>
      </p:pic>
      <p:sp>
        <p:nvSpPr>
          <p:cNvPr id="133" name="8 CuadroTexto"/>
          <p:cNvSpPr/>
          <p:nvPr/>
        </p:nvSpPr>
        <p:spPr>
          <a:xfrm>
            <a:off x="468360" y="5661000"/>
            <a:ext cx="21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</a:rPr>
              <a:t>PHOBIC &gt; CLEA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9 CuadroTexto"/>
          <p:cNvSpPr/>
          <p:nvPr/>
        </p:nvSpPr>
        <p:spPr>
          <a:xfrm>
            <a:off x="3419640" y="5661000"/>
            <a:ext cx="216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</a:rPr>
              <a:t>PHOBIC &gt; DIRT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10 CuadroTexto"/>
          <p:cNvSpPr/>
          <p:nvPr/>
        </p:nvSpPr>
        <p:spPr>
          <a:xfrm>
            <a:off x="6372360" y="5661000"/>
            <a:ext cx="216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</a:rPr>
              <a:t>DIRTY &gt; CLEA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marL="990720" indent="-990720">
              <a:lnSpc>
                <a:spcPct val="80000"/>
              </a:lnSpc>
              <a:buSzPct val="154331"/>
              <a:buBlip>
                <a:blip r:embed="rId1"/>
              </a:buBlip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3600" spc="-1" strike="noStrike">
                <a:solidFill>
                  <a:srgbClr val="da0000"/>
                </a:solidFill>
                <a:latin typeface="Arial"/>
              </a:rPr>
              <a:t>DISCUSSION</a:t>
            </a: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137" name=""/>
          <p:cNvSpPr txBox="1"/>
          <p:nvPr/>
        </p:nvSpPr>
        <p:spPr>
          <a:xfrm>
            <a:off x="971640" y="1557000"/>
            <a:ext cx="7704000" cy="4608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92000"/>
          </a:bodyPr>
          <a:p>
            <a:pPr marL="161640" indent="-1616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Main results </a:t>
            </a:r>
            <a:r>
              <a:rPr b="0" lang="en-US" sz="1600" spc="-1" strike="noStrike">
                <a:solidFill>
                  <a:srgbClr val="4d4d4d"/>
                </a:solidFill>
                <a:latin typeface="Wingdings"/>
                <a:ea typeface="Wingdings"/>
              </a:rPr>
              <a:t>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“phobic&gt;clean” 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contrast: reflect the fear and anxiety felt by the subjects due to the phobic stimulus when compared with a emotionally neutral situation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1640" indent="-1616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1640" indent="-1616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Occipital lobe 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(activated in its left inferior area and in the middle lobe bilaterally): controls the visual areas. Paquette et al. (2003)</a:t>
            </a:r>
            <a:r>
              <a:rPr b="0" lang="en-US" sz="1600" spc="-1" strike="noStrike">
                <a:solidFill>
                  <a:srgbClr val="4d4d4d"/>
                </a:solidFill>
                <a:latin typeface="Wingdings"/>
                <a:ea typeface="Wingdings"/>
              </a:rPr>
              <a:t>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concluded that this activation was related with enhanced visual attention to the phobic stimuli, and support vigilance functions in anxiety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1640" indent="-1616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1640" indent="-1616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Superior frontal gyrus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: related to the feeling of self-awareness, which is increased when the phobic subject watches the animal that provokes his fear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1640" indent="-1616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1640" indent="-1616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Cuneus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: related to visual processing, which is directly associated with the sense of presence that the subject feels while navigating through a virtual environment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1640" indent="-1616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1640" indent="-1616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Precuneus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: related to self-consciousness, such as reflective self-awareness, that involves rating your own personality traits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1640" indent="-1616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1640" indent="-1616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	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138" name="3 Marcador de número de diapositiva"/>
          <p:cNvSpPr/>
          <p:nvPr/>
        </p:nvSpPr>
        <p:spPr>
          <a:xfrm>
            <a:off x="34920" y="0"/>
            <a:ext cx="1008000" cy="40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9c0000"/>
                </a:solidFill>
                <a:latin typeface="Arial"/>
              </a:rPr>
              <a:t>0</a:t>
            </a:r>
            <a:fld id="{0646CA5A-7D9B-4FCB-AC75-1965D636A9F4}" type="slidenum">
              <a:rPr b="0" lang="es-ES" sz="1800" spc="-1" strike="noStrike">
                <a:solidFill>
                  <a:srgbClr val="9c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9" name="Picture 6" descr=""/>
          <p:cNvPicPr/>
          <p:nvPr/>
        </p:nvPicPr>
        <p:blipFill>
          <a:blip r:embed="rId2"/>
          <a:srcRect l="4169" t="1711" r="5452" b="4103"/>
          <a:stretch/>
        </p:blipFill>
        <p:spPr>
          <a:xfrm>
            <a:off x="7483320" y="0"/>
            <a:ext cx="1660680" cy="1521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marL="990720" indent="-990720">
              <a:lnSpc>
                <a:spcPct val="80000"/>
              </a:lnSpc>
              <a:buSzPct val="154331"/>
              <a:buBlip>
                <a:blip r:embed="rId1"/>
              </a:buBlip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3600" spc="-1" strike="noStrike">
                <a:solidFill>
                  <a:srgbClr val="da0000"/>
                </a:solidFill>
                <a:latin typeface="Arial"/>
              </a:rPr>
              <a:t>DISCUSSION</a:t>
            </a: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141" name=""/>
          <p:cNvSpPr txBox="1"/>
          <p:nvPr/>
        </p:nvSpPr>
        <p:spPr>
          <a:xfrm>
            <a:off x="1405080" y="1557000"/>
            <a:ext cx="7704000" cy="4608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99000"/>
          </a:bodyPr>
          <a:p>
            <a:pPr marL="174240" indent="-174240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	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“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phobic&gt;dirty” 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contrast: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1" marL="615960" indent="-182160">
              <a:spcBef>
                <a:spcPts val="400"/>
              </a:spcBef>
              <a:buClr>
                <a:srgbClr val="ff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inferior occipital lobe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bilaterally </a:t>
            </a:r>
            <a:r>
              <a:rPr b="0" lang="en-US" sz="1600" spc="-1" strike="noStrike">
                <a:solidFill>
                  <a:srgbClr val="4d4d4d"/>
                </a:solidFill>
                <a:latin typeface="Wingdings"/>
                <a:ea typeface="Wingdings"/>
              </a:rPr>
              <a:t>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in concordance with the “phobic&gt;clean” contrast </a:t>
            </a:r>
            <a:r>
              <a:rPr b="0" lang="en-US" sz="1600" spc="-1" strike="noStrike">
                <a:solidFill>
                  <a:srgbClr val="4d4d4d"/>
                </a:solidFill>
                <a:latin typeface="Wingdings"/>
                <a:ea typeface="Wingdings"/>
              </a:rPr>
              <a:t>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related to enhance visual attention to the phobic stimuli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1" marL="615960" indent="-182160">
              <a:spcBef>
                <a:spcPts val="400"/>
              </a:spcBef>
              <a:buClr>
                <a:srgbClr val="ff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superior and middle frontal lobe </a:t>
            </a:r>
            <a:r>
              <a:rPr b="0" lang="en-US" sz="1600" spc="-1" strike="noStrike">
                <a:solidFill>
                  <a:srgbClr val="4d4d4d"/>
                </a:solidFill>
                <a:latin typeface="Wingdings"/>
                <a:ea typeface="Wingdings"/>
              </a:rPr>
              <a:t>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in concordance with the “phobic&gt;clean” contrast </a:t>
            </a:r>
            <a:r>
              <a:rPr b="0" lang="en-US" sz="1600" spc="-1" strike="noStrike">
                <a:solidFill>
                  <a:srgbClr val="4d4d4d"/>
                </a:solidFill>
                <a:latin typeface="Wingdings"/>
                <a:ea typeface="Wingdings"/>
              </a:rPr>
              <a:t>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related to the feeling of self-awareness and the action of the sensory system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1" marL="615960" indent="-182160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The main results related to the phobia are still activated when we restrict the conditions of the contrast to avoid the anxiety results.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1" marL="615960" indent="-182160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1" marL="615960" indent="-182160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“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irty&gt;clean” 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contrast: 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1" marL="615960" indent="-182160">
              <a:spcBef>
                <a:spcPts val="400"/>
              </a:spcBef>
              <a:buClr>
                <a:srgbClr val="ff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middle frontal gyrus </a:t>
            </a:r>
            <a:r>
              <a:rPr b="0" lang="en-US" sz="1600" spc="-1" strike="noStrike">
                <a:solidFill>
                  <a:srgbClr val="4d4d4d"/>
                </a:solidFill>
                <a:latin typeface="Wingdings"/>
                <a:ea typeface="Wingdings"/>
              </a:rPr>
              <a:t>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the self-awareness is still high, due to the greater fear of finding a spider or cockroach when navigating through a dark and dirty environment than when navigating through a clean one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1" marL="615960" indent="-182160">
              <a:spcBef>
                <a:spcPts val="400"/>
              </a:spcBef>
              <a:buClr>
                <a:srgbClr val="ff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occipital lobe </a:t>
            </a:r>
            <a:r>
              <a:rPr b="0" lang="en-US" sz="1600" spc="-1" strike="noStrike">
                <a:solidFill>
                  <a:srgbClr val="4d4d4d"/>
                </a:solidFill>
                <a:latin typeface="Wingdings"/>
                <a:ea typeface="Wingdings"/>
              </a:rPr>
              <a:t>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is maintained here due to the higher visual processing when expecting the appearance of a feared animal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1" marL="615960" indent="-182160">
              <a:spcBef>
                <a:spcPts val="400"/>
              </a:spcBef>
              <a:buClr>
                <a:srgbClr val="ff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cingulate gyrus </a:t>
            </a:r>
            <a:r>
              <a:rPr b="0" lang="en-US" sz="1600" spc="-1" strike="noStrike">
                <a:solidFill>
                  <a:srgbClr val="4d4d4d"/>
                </a:solidFill>
                <a:latin typeface="Wingdings"/>
                <a:ea typeface="Wingdings"/>
              </a:rPr>
              <a:t>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mainly associated with the cognitive/internal generation of emotional state by evoking visual imagery or memories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lvl="1" marL="615960" indent="-182160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142" name="3 Marcador de número de diapositiva"/>
          <p:cNvSpPr/>
          <p:nvPr/>
        </p:nvSpPr>
        <p:spPr>
          <a:xfrm>
            <a:off x="34920" y="0"/>
            <a:ext cx="1008000" cy="40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9c0000"/>
                </a:solidFill>
                <a:latin typeface="Arial"/>
              </a:rPr>
              <a:t>0</a:t>
            </a:r>
            <a:fld id="{8123D605-FB30-4C9A-90AC-B05E2788B69D}" type="slidenum">
              <a:rPr b="0" lang="es-ES" sz="1800" spc="-1" strike="noStrike">
                <a:solidFill>
                  <a:srgbClr val="9c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3" name="Picture 7" descr=""/>
          <p:cNvPicPr/>
          <p:nvPr/>
        </p:nvPicPr>
        <p:blipFill>
          <a:blip r:embed="rId2"/>
          <a:stretch/>
        </p:blipFill>
        <p:spPr>
          <a:xfrm>
            <a:off x="39600" y="2133720"/>
            <a:ext cx="1652760" cy="1511280"/>
          </a:xfrm>
          <a:prstGeom prst="rect">
            <a:avLst/>
          </a:prstGeom>
          <a:ln w="0">
            <a:noFill/>
          </a:ln>
        </p:spPr>
      </p:pic>
      <p:pic>
        <p:nvPicPr>
          <p:cNvPr id="144" name="Picture 8" descr=""/>
          <p:cNvPicPr/>
          <p:nvPr/>
        </p:nvPicPr>
        <p:blipFill>
          <a:blip r:embed="rId3"/>
          <a:stretch/>
        </p:blipFill>
        <p:spPr>
          <a:xfrm>
            <a:off x="23760" y="4508640"/>
            <a:ext cx="1668600" cy="1512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marL="990720" indent="-990720">
              <a:lnSpc>
                <a:spcPct val="80000"/>
              </a:lnSpc>
              <a:buSzPct val="154331"/>
              <a:buBlip>
                <a:blip r:embed="rId1"/>
              </a:buBlip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3600" spc="-1" strike="noStrike">
                <a:solidFill>
                  <a:srgbClr val="da0000"/>
                </a:solidFill>
                <a:latin typeface="Arial"/>
              </a:rPr>
              <a:t>DISCUSSION</a:t>
            </a: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146" name=""/>
          <p:cNvSpPr txBox="1"/>
          <p:nvPr/>
        </p:nvSpPr>
        <p:spPr>
          <a:xfrm>
            <a:off x="971640" y="1557000"/>
            <a:ext cx="7704000" cy="4608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99000"/>
          </a:bodyPr>
          <a:p>
            <a:pPr marL="174240" indent="-1742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Although one of the areas most commonly related to phobias is the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mygdala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, it is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ot activated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in our results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4240" indent="-1742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4240" indent="-1742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Several previous studies have been conducted to find the pattern of activation of this area, concluding that it suffers </a:t>
            </a: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habituation over time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4240" indent="-1742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4240" indent="-1742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Paquette et al. (2003) pointed out that the amygdala may not be related to the phobic expression or experience, but to the fear conditioning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4240" indent="-1742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4240" indent="-1742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Straube et al. (2007) discussed that the amygdala activation may occur during </a:t>
            </a: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brief presentations 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of the phobogenic stimuli and in the induction of rapid behavioral responses more than in the sustained and explicit processing of the threatening stimuli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4240" indent="-1742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4240" indent="-1742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In our case, the use of periods of navigation instead of pictures may be the cause of not detecting activation in this area (we used a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block design 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for the protocol instead of an event-related)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4240" indent="-1742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147" name="3 Marcador de número de diapositiva"/>
          <p:cNvSpPr/>
          <p:nvPr/>
        </p:nvSpPr>
        <p:spPr>
          <a:xfrm>
            <a:off x="34920" y="0"/>
            <a:ext cx="1008000" cy="40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9c0000"/>
                </a:solidFill>
                <a:latin typeface="Arial"/>
              </a:rPr>
              <a:t>0</a:t>
            </a:r>
            <a:fld id="{C9470889-3C04-4EFC-988D-4B85FDC0664D}" type="slidenum">
              <a:rPr b="0" lang="es-ES" sz="1800" spc="-1" strike="noStrike">
                <a:solidFill>
                  <a:srgbClr val="9c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marL="990720" indent="-990720">
              <a:lnSpc>
                <a:spcPct val="80000"/>
              </a:lnSpc>
              <a:buSzPct val="154331"/>
              <a:buBlip>
                <a:blip r:embed="rId1"/>
              </a:buBlip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3600" spc="-1" strike="noStrike">
                <a:solidFill>
                  <a:srgbClr val="da0000"/>
                </a:solidFill>
                <a:latin typeface="Arial"/>
              </a:rPr>
              <a:t>Conclusions</a:t>
            </a: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149" name=""/>
          <p:cNvSpPr txBox="1"/>
          <p:nvPr/>
        </p:nvSpPr>
        <p:spPr>
          <a:xfrm>
            <a:off x="971640" y="1557000"/>
            <a:ext cx="7704000" cy="4608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We have obtained with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R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similar results in terms of fMRI brain activations to those obtained using real stimuli.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In fact, the main activations we found in the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occipital and frontal areas 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are coherent with those found in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previous studies 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conducted with spider phobic subjects using pictures or videos of real animals as stimuli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This finding opens the door to deeper investigations over the phobias, due to the fact that VR allows recreation of normal life scenes in a more realistic and interactive way, that are impossible to achieve with other techniques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This kind of situations could allow, for example, the study over subjects with a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mild phobia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, whose fear cannot be excited only by the use of photographs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150" name="3 Marcador de número de diapositiva"/>
          <p:cNvSpPr/>
          <p:nvPr/>
        </p:nvSpPr>
        <p:spPr>
          <a:xfrm>
            <a:off x="34920" y="0"/>
            <a:ext cx="1008000" cy="40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9c0000"/>
                </a:solidFill>
                <a:latin typeface="Arial"/>
              </a:rPr>
              <a:t>0</a:t>
            </a:r>
            <a:fld id="{A1253CE5-AC3A-424C-9C46-D14C8F998A65}" type="slidenum">
              <a:rPr b="0" lang="es-ES" sz="1800" spc="-1" strike="noStrike">
                <a:solidFill>
                  <a:srgbClr val="9c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PlaceHolder 1"/>
          <p:cNvSpPr>
            <a:spLocks noGrp="1"/>
          </p:cNvSpPr>
          <p:nvPr>
            <p:ph type="title"/>
          </p:nvPr>
        </p:nvSpPr>
        <p:spPr>
          <a:xfrm>
            <a:off x="-360" y="3286080"/>
            <a:ext cx="8675640" cy="1152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marL="990720" indent="-990720" algn="ctr">
              <a:lnSpc>
                <a:spcPct val="80000"/>
              </a:lnSpc>
              <a:buSzPct val="154331"/>
              <a:buBlip>
                <a:blip r:embed="rId1"/>
              </a:buBlip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3600" spc="-1" strike="noStrike">
                <a:solidFill>
                  <a:srgbClr val="da0000"/>
                </a:solidFill>
                <a:latin typeface="Arial"/>
              </a:rPr>
              <a:t>THANKS FOR YOUR ATTENTION</a:t>
            </a:r>
            <a:br>
              <a:rPr sz="3600"/>
            </a:br>
            <a:br>
              <a:rPr sz="3600"/>
            </a:br>
            <a:r>
              <a:rPr b="1" lang="es-ES" sz="2400" spc="-1" strike="noStrike">
                <a:solidFill>
                  <a:srgbClr val="da0000"/>
                </a:solidFill>
                <a:latin typeface="Arial"/>
              </a:rPr>
              <a:t>Questions can be sent to: </a:t>
            </a:r>
            <a:br>
              <a:rPr sz="2400"/>
            </a:br>
            <a:br>
              <a:rPr sz="2400"/>
            </a:br>
            <a:r>
              <a:rPr b="1" lang="es-ES" sz="2400" spc="-1" strike="noStrike" u="sng">
                <a:solidFill>
                  <a:srgbClr val="009999"/>
                </a:solidFill>
                <a:uFillTx/>
                <a:latin typeface="Arial"/>
                <a:hlinkClick r:id="rId2"/>
              </a:rPr>
              <a:t>mclemente@labhuman.i3bh.es</a:t>
            </a:r>
            <a:r>
              <a:rPr b="1" lang="es-ES" sz="2400" spc="-1" strike="noStrike">
                <a:solidFill>
                  <a:srgbClr val="da0000"/>
                </a:solidFill>
                <a:latin typeface="Arial"/>
              </a:rPr>
              <a:t> </a:t>
            </a:r>
            <a:endParaRPr b="1" lang="en-US" sz="24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152" name="3 Marcador de número de diapositiva"/>
          <p:cNvSpPr/>
          <p:nvPr/>
        </p:nvSpPr>
        <p:spPr>
          <a:xfrm>
            <a:off x="34920" y="0"/>
            <a:ext cx="1008000" cy="40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9c0000"/>
                </a:solidFill>
                <a:latin typeface="Arial"/>
              </a:rPr>
              <a:t>0</a:t>
            </a:r>
            <a:fld id="{85FB4D47-BC3D-4867-B27C-FEE30F482A36}" type="slidenum">
              <a:rPr b="0" lang="es-ES" sz="1800" spc="-1" strike="noStrike">
                <a:solidFill>
                  <a:srgbClr val="9c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title"/>
          </p:nvPr>
        </p:nvSpPr>
        <p:spPr>
          <a:xfrm>
            <a:off x="34920" y="1557360"/>
            <a:ext cx="7561440" cy="2448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marL="1073160" indent="-897120" algn="ctr">
              <a:lnSpc>
                <a:spcPct val="80000"/>
              </a:lnSpc>
              <a:buSzPct val="128571"/>
              <a:buBlip>
                <a:blip r:embed="rId1"/>
              </a:buBlip>
              <a:tabLst>
                <a:tab algn="l" pos="2146320"/>
                <a:tab algn="l" pos="3219480"/>
                <a:tab algn="l" pos="4292640"/>
                <a:tab algn="l" pos="5365800"/>
                <a:tab algn="l" pos="6438960"/>
                <a:tab algn="l" pos="7512120"/>
                <a:tab algn="l" pos="8585280"/>
                <a:tab algn="l" pos="9658440"/>
                <a:tab algn="l" pos="10731600"/>
              </a:tabLst>
            </a:pPr>
            <a:r>
              <a:rPr b="1" i="1" lang="en-US" sz="3600" spc="-1" strike="noStrike">
                <a:solidFill>
                  <a:srgbClr val="ffffff"/>
                </a:solidFill>
                <a:latin typeface="Arial"/>
              </a:rPr>
              <a:t>fMRI assessment of small animals’ phobia using virtual reality as stimulus</a:t>
            </a:r>
            <a:r>
              <a:rPr b="1" lang="en-US" sz="3600" spc="-1" strike="noStrike">
                <a:solidFill>
                  <a:srgbClr val="ffffff"/>
                </a:solidFill>
                <a:latin typeface="Arial"/>
              </a:rPr>
              <a:t> </a:t>
            </a:r>
            <a:br>
              <a:rPr sz="3600"/>
            </a:br>
            <a:br>
              <a:rPr sz="3600"/>
            </a:br>
            <a:r>
              <a:rPr b="1" lang="es-ES" sz="3600" spc="-1" strike="noStrike">
                <a:solidFill>
                  <a:srgbClr val="ffffff"/>
                </a:solidFill>
                <a:latin typeface="Arial"/>
              </a:rPr>
              <a:t> </a:t>
            </a: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81" name="PlaceHolder 2"/>
          <p:cNvSpPr>
            <a:spLocks noGrp="1"/>
          </p:cNvSpPr>
          <p:nvPr>
            <p:ph type="subTitle"/>
          </p:nvPr>
        </p:nvSpPr>
        <p:spPr>
          <a:xfrm>
            <a:off x="1285920" y="3429000"/>
            <a:ext cx="6400800" cy="571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2400" spc="-1" strike="noStrike">
                <a:solidFill>
                  <a:srgbClr val="ffffff"/>
                </a:solidFill>
                <a:latin typeface="Arial"/>
              </a:rPr>
              <a:t>Patients Rehabilitation Research Techniques Workshop, Venice 2013</a:t>
            </a:r>
            <a:endParaRPr b="0" lang="en-US" sz="24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82" name="6 CuadroTexto"/>
          <p:cNvSpPr/>
          <p:nvPr/>
        </p:nvSpPr>
        <p:spPr>
          <a:xfrm>
            <a:off x="539640" y="4797360"/>
            <a:ext cx="580068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Arial"/>
              </a:rPr>
              <a:t>Miriam CLEMENTE</a:t>
            </a:r>
            <a:r>
              <a:rPr b="0" lang="en-US" sz="1400" spc="-1" strike="noStrike">
                <a:solidFill>
                  <a:srgbClr val="ffffff"/>
                </a:solidFill>
                <a:latin typeface="Arial"/>
              </a:rPr>
              <a:t>, Beatriz REY, Aina RODRÍGUEZ-PUJADAS, Juani BRETÓN-LÓPEZ, Alfonso BARROS-LOSCERTALES, Rosa M. BAÑOS, Cristina BOTELLA, Mariano ALCAÑIZ, and César ÁVIL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4 Imagen" descr="resonancia.jpg"/>
          <p:cNvPicPr/>
          <p:nvPr/>
        </p:nvPicPr>
        <p:blipFill>
          <a:blip r:embed="rId1">
            <a:lum bright="70000" contrast="-70000"/>
          </a:blip>
          <a:stretch/>
        </p:blipFill>
        <p:spPr>
          <a:xfrm>
            <a:off x="0" y="3286080"/>
            <a:ext cx="4071960" cy="3054240"/>
          </a:xfrm>
          <a:prstGeom prst="rect">
            <a:avLst/>
          </a:prstGeom>
          <a:ln w="0">
            <a:noFill/>
          </a:ln>
        </p:spPr>
      </p:pic>
      <p:sp>
        <p:nvSpPr>
          <p:cNvPr id="84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marL="990720" indent="-990720">
              <a:lnSpc>
                <a:spcPct val="80000"/>
              </a:lnSpc>
              <a:buSzPct val="154331"/>
              <a:buBlip>
                <a:blip r:embed="rId2"/>
              </a:buBlip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3600" spc="-1" strike="noStrike">
                <a:solidFill>
                  <a:srgbClr val="da0000"/>
                </a:solidFill>
                <a:latin typeface="Arial"/>
              </a:rPr>
              <a:t>INTRODUCTION</a:t>
            </a: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85" name=""/>
          <p:cNvSpPr txBox="1"/>
          <p:nvPr/>
        </p:nvSpPr>
        <p:spPr>
          <a:xfrm>
            <a:off x="285480" y="1557000"/>
            <a:ext cx="8389800" cy="4608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176040" indent="-1760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Many studies have taken advantage of the goodness of fMRI for analyzing brain activation.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Advantages: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Non invasive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Non secondary effects </a:t>
            </a:r>
            <a:r>
              <a:rPr b="0" lang="en-US" sz="1600" spc="-1" strike="noStrike">
                <a:solidFill>
                  <a:srgbClr val="4d4d4d"/>
                </a:solidFill>
                <a:latin typeface="Wingdings"/>
                <a:ea typeface="Wingdings"/>
              </a:rPr>
              <a:t>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we can repeat the experiment several times and compare the results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  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  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The fMRI technique is based on the monitoring of changes in the blood oxygenation and blood flow in the brain. It has a spatial resolution between 1 and 3 mm, and a temporal resolution in the order of 1s for the complete volume of the brain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Disadvantages: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Long exploration times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Big and expensive machinery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Metallic objects not allowed inside the magnetic field </a:t>
            </a:r>
            <a:r>
              <a:rPr b="0" lang="en-US" sz="1600" spc="-1" strike="noStrike">
                <a:solidFill>
                  <a:srgbClr val="4d4d4d"/>
                </a:solidFill>
                <a:latin typeface="Wingdings"/>
                <a:ea typeface="Wingdings"/>
              </a:rPr>
              <a:t>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we need adapted machinery: glasses to show the environments and joystick to navigate along them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86" name="3 Marcador de número de diapositiva"/>
          <p:cNvSpPr/>
          <p:nvPr/>
        </p:nvSpPr>
        <p:spPr>
          <a:xfrm>
            <a:off x="34920" y="0"/>
            <a:ext cx="1008000" cy="40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9c0000"/>
                </a:solidFill>
                <a:latin typeface="Arial"/>
              </a:rPr>
              <a:t>0</a:t>
            </a:r>
            <a:fld id="{84BF5B98-6121-40AB-A5AA-66EF2DCBD35D}" type="slidenum">
              <a:rPr b="0" lang="es-ES" sz="1800" spc="-1" strike="noStrike">
                <a:solidFill>
                  <a:srgbClr val="9c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" name="5 Imagen" descr=""/>
          <p:cNvPicPr/>
          <p:nvPr/>
        </p:nvPicPr>
        <p:blipFill>
          <a:blip r:embed="rId3">
            <a:lum bright="70000" contrast="-70000"/>
          </a:blip>
          <a:srcRect l="0" t="33608" r="0" b="55469"/>
          <a:stretch/>
        </p:blipFill>
        <p:spPr>
          <a:xfrm>
            <a:off x="4572000" y="1857240"/>
            <a:ext cx="4572000" cy="928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8" name="5 Imagen" descr="post-cucaracha.jpg"/>
          <p:cNvPicPr/>
          <p:nvPr/>
        </p:nvPicPr>
        <p:blipFill>
          <a:blip r:embed="rId1"/>
          <a:stretch/>
        </p:blipFill>
        <p:spPr>
          <a:xfrm>
            <a:off x="4925880" y="2706840"/>
            <a:ext cx="3413160" cy="3419280"/>
          </a:xfrm>
          <a:prstGeom prst="rect">
            <a:avLst/>
          </a:prstGeom>
          <a:ln w="0">
            <a:noFill/>
          </a:ln>
        </p:spPr>
      </p:pic>
      <p:pic>
        <p:nvPicPr>
          <p:cNvPr id="89" name="4 Imagen" descr="lgebr_spider.jpg"/>
          <p:cNvPicPr/>
          <p:nvPr/>
        </p:nvPicPr>
        <p:blipFill>
          <a:blip r:embed="rId2"/>
          <a:stretch/>
        </p:blipFill>
        <p:spPr>
          <a:xfrm>
            <a:off x="493560" y="1494000"/>
            <a:ext cx="3584880" cy="3657600"/>
          </a:xfrm>
          <a:prstGeom prst="rect">
            <a:avLst/>
          </a:prstGeom>
          <a:ln w="0">
            <a:noFill/>
          </a:ln>
        </p:spPr>
      </p:pic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marL="990720" indent="-990720">
              <a:lnSpc>
                <a:spcPct val="80000"/>
              </a:lnSpc>
              <a:buSzPct val="154331"/>
              <a:buBlip>
                <a:blip r:embed="rId3"/>
              </a:buBlip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3600" spc="-1" strike="noStrike">
                <a:solidFill>
                  <a:srgbClr val="da0000"/>
                </a:solidFill>
                <a:latin typeface="Arial"/>
              </a:rPr>
              <a:t>INTRODUCTION</a:t>
            </a: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91" name=""/>
          <p:cNvSpPr txBox="1"/>
          <p:nvPr/>
        </p:nvSpPr>
        <p:spPr>
          <a:xfrm>
            <a:off x="285480" y="1557000"/>
            <a:ext cx="8389800" cy="4608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There are many areas where fMRI’s studies can take place, such as the study of mental illness, search of tumors or investigations about brain performance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We are interested in analyzing the activation during a concrete mental illness: the </a:t>
            </a:r>
            <a:r>
              <a:rPr b="1" lang="en-US" sz="1800" spc="-1" strike="noStrike">
                <a:solidFill>
                  <a:srgbClr val="c00000"/>
                </a:solidFill>
                <a:latin typeface="Arial"/>
              </a:rPr>
              <a:t>phobia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, and, more precisely, the </a:t>
            </a:r>
            <a:r>
              <a:rPr b="1" lang="en-US" sz="1800" spc="-1" strike="noStrike">
                <a:solidFill>
                  <a:srgbClr val="c00000"/>
                </a:solidFill>
                <a:latin typeface="Arial"/>
              </a:rPr>
              <a:t>spider’s and cockroach’s phobia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.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Phobias are one of the most spread and common disorders of the modern life, affecting one person in 10 at some point of their lives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More specifically, small animals’ phobia is one of the most disabling ones, due to the possibility of facing the animal that is the focus of the phobia in daily life.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This phobia consists in an irrational fear before any possible contact with the animal in question. This fear is joined to a continuous state of </a:t>
            </a:r>
            <a:r>
              <a:rPr b="1" lang="en-US" sz="1600" spc="-1" strike="noStrike">
                <a:solidFill>
                  <a:srgbClr val="c00000"/>
                </a:solidFill>
                <a:latin typeface="Arial"/>
              </a:rPr>
              <a:t>anxiety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before the possibility of finding it, a </a:t>
            </a:r>
            <a:r>
              <a:rPr b="1" lang="en-US" sz="1600" spc="-1" strike="noStrike">
                <a:solidFill>
                  <a:srgbClr val="c00000"/>
                </a:solidFill>
                <a:latin typeface="Arial"/>
              </a:rPr>
              <a:t>repulsion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response before any representation of it and a </a:t>
            </a:r>
            <a:r>
              <a:rPr b="1" lang="en-US" sz="1600" spc="-1" strike="noStrike">
                <a:solidFill>
                  <a:srgbClr val="c00000"/>
                </a:solidFill>
                <a:latin typeface="Arial"/>
              </a:rPr>
              <a:t>defensive reaction 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in case of contact.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92" name="3 Marcador de número de diapositiva"/>
          <p:cNvSpPr/>
          <p:nvPr/>
        </p:nvSpPr>
        <p:spPr>
          <a:xfrm>
            <a:off x="34920" y="0"/>
            <a:ext cx="1008000" cy="40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9c0000"/>
                </a:solidFill>
                <a:latin typeface="Arial"/>
              </a:rPr>
              <a:t>0</a:t>
            </a:r>
            <a:fld id="{4098D116-2DAA-4E24-A799-9AE0D902E777}" type="slidenum">
              <a:rPr b="0" lang="es-ES" sz="1800" spc="-1" strike="noStrike">
                <a:solidFill>
                  <a:srgbClr val="9c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marL="990720" indent="-990720">
              <a:lnSpc>
                <a:spcPct val="80000"/>
              </a:lnSpc>
              <a:buSzPct val="154331"/>
              <a:buBlip>
                <a:blip r:embed="rId1"/>
              </a:buBlip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3600" spc="-1" strike="noStrike">
                <a:solidFill>
                  <a:srgbClr val="da0000"/>
                </a:solidFill>
                <a:latin typeface="Arial"/>
              </a:rPr>
              <a:t>INTRODUCTION</a:t>
            </a: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94" name=""/>
          <p:cNvSpPr txBox="1"/>
          <p:nvPr/>
        </p:nvSpPr>
        <p:spPr>
          <a:xfrm>
            <a:off x="428760" y="1412640"/>
            <a:ext cx="8246880" cy="4608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94000"/>
          </a:bodyPr>
          <a:p>
            <a:pPr marL="165240" indent="-1652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Some experiments have been done before about the spider’s phobia with fMRI, studying the activation of brain areas such as the amygdale. </a:t>
            </a:r>
            <a:r>
              <a:rPr b="1" lang="en-US" sz="1600" spc="-1" strike="noStrike">
                <a:solidFill>
                  <a:srgbClr val="c00000"/>
                </a:solidFill>
                <a:latin typeface="Arial"/>
              </a:rPr>
              <a:t>Paquette et al. (2003) 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analyzed brain activity using fMRI before and after a mental treatment to observe the differences between both moments. They obtained that the brain areas related with the phobia stopped being activated after the treatment.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Much research has been done combining </a:t>
            </a:r>
            <a:r>
              <a:rPr b="1" lang="en-US" sz="1600" spc="-1" strike="noStrike">
                <a:solidFill>
                  <a:srgbClr val="c00000"/>
                </a:solidFill>
                <a:latin typeface="Arial"/>
              </a:rPr>
              <a:t>VR with fMRI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, for example, for motor rehabilitation or for pain distraction. However, the research field of phobias combined with VR and fMRI is unexplored yet. 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VR has been used as treatment itself, but not for presenting stimulus during an experiment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Previous studies about phobias with fMRI use images (photographs or videos) of real animals to stimulate the activation of the brain areas related to the phobia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The principal aim of our study is to examine if VR can be used for the assessment of the phobia, provoking a more realistic and immersive situation than the view of a still photograph.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95" name="3 Marcador de número de diapositiva"/>
          <p:cNvSpPr/>
          <p:nvPr/>
        </p:nvSpPr>
        <p:spPr>
          <a:xfrm>
            <a:off x="34920" y="0"/>
            <a:ext cx="1008000" cy="40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9c0000"/>
                </a:solidFill>
                <a:latin typeface="Arial"/>
              </a:rPr>
              <a:t>0</a:t>
            </a:r>
            <a:fld id="{1E2FAB49-A346-46FC-AF06-5CC207ABEDC8}" type="slidenum">
              <a:rPr b="0" lang="es-ES" sz="1800" spc="-1" strike="noStrike">
                <a:solidFill>
                  <a:srgbClr val="9c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6" name="5 Imagen" descr="araña.JPG"/>
          <p:cNvPicPr/>
          <p:nvPr/>
        </p:nvPicPr>
        <p:blipFill>
          <a:blip r:embed="rId2"/>
          <a:stretch/>
        </p:blipFill>
        <p:spPr>
          <a:xfrm>
            <a:off x="7143840" y="44280"/>
            <a:ext cx="1666800" cy="1395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marL="990720" indent="-990720">
              <a:lnSpc>
                <a:spcPct val="80000"/>
              </a:lnSpc>
              <a:buSzPct val="154331"/>
              <a:buBlip>
                <a:blip r:embed="rId1"/>
              </a:buBlip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3600" spc="-1" strike="noStrike">
                <a:solidFill>
                  <a:srgbClr val="da0000"/>
                </a:solidFill>
                <a:latin typeface="Arial"/>
              </a:rPr>
              <a:t>METHOD</a:t>
            </a: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98" name=""/>
          <p:cNvSpPr txBox="1"/>
          <p:nvPr/>
        </p:nvSpPr>
        <p:spPr>
          <a:xfrm>
            <a:off x="214200" y="1557000"/>
            <a:ext cx="8461440" cy="48718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94000"/>
          </a:bodyPr>
          <a:p>
            <a:pPr marL="165240" indent="-1652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 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The study was conducted in the Hospital General of Castellon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The subjects wore special glasses used to visualize the environment and a helmet to fix their head and avoid the movement. Subjects also used a joystick to navigate along the environment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  </a:t>
            </a:r>
            <a:r>
              <a:rPr b="1" lang="en-US" sz="1600" spc="-1" strike="noStrike">
                <a:solidFill>
                  <a:srgbClr val="c00000"/>
                </a:solidFill>
                <a:latin typeface="Arial"/>
              </a:rPr>
              <a:t>Both glasses and joystick were adapted to the magnetic fields inside the magnetic resonance unit (1.5 Tesla)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The virtual environments have been developed with GameStudio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65240" indent="-1652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	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99" name="3 Marcador de número de diapositiva"/>
          <p:cNvSpPr/>
          <p:nvPr/>
        </p:nvSpPr>
        <p:spPr>
          <a:xfrm>
            <a:off x="34920" y="0"/>
            <a:ext cx="1008000" cy="40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9c0000"/>
                </a:solidFill>
                <a:latin typeface="Arial"/>
              </a:rPr>
              <a:t>0</a:t>
            </a:r>
            <a:fld id="{BC5ED52C-1270-4201-852E-E3143BF9322E}" type="slidenum">
              <a:rPr b="0" lang="es-ES" sz="1800" spc="-1" strike="noStrike">
                <a:solidFill>
                  <a:srgbClr val="9c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0" name="4 Imagen" descr="vsd-02.jpg"/>
          <p:cNvPicPr/>
          <p:nvPr/>
        </p:nvPicPr>
        <p:blipFill>
          <a:blip r:embed="rId2"/>
          <a:stretch/>
        </p:blipFill>
        <p:spPr>
          <a:xfrm>
            <a:off x="1285920" y="3571920"/>
            <a:ext cx="2400120" cy="2000160"/>
          </a:xfrm>
          <a:prstGeom prst="rect">
            <a:avLst/>
          </a:prstGeom>
          <a:ln w="0">
            <a:noFill/>
          </a:ln>
        </p:spPr>
      </p:pic>
      <p:pic>
        <p:nvPicPr>
          <p:cNvPr id="101" name="6 Imagen" descr="joystick.tif"/>
          <p:cNvPicPr/>
          <p:nvPr/>
        </p:nvPicPr>
        <p:blipFill>
          <a:blip r:embed="rId3"/>
          <a:stretch/>
        </p:blipFill>
        <p:spPr>
          <a:xfrm>
            <a:off x="4429080" y="3571920"/>
            <a:ext cx="2666880" cy="2000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marL="990720" indent="-990720">
              <a:lnSpc>
                <a:spcPct val="80000"/>
              </a:lnSpc>
              <a:buSzPct val="154331"/>
              <a:buBlip>
                <a:blip r:embed="rId1"/>
              </a:buBlip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3600" spc="-1" strike="noStrike">
                <a:solidFill>
                  <a:srgbClr val="da0000"/>
                </a:solidFill>
                <a:latin typeface="Arial"/>
              </a:rPr>
              <a:t>METHOD</a:t>
            </a: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103" name=""/>
          <p:cNvSpPr txBox="1"/>
          <p:nvPr/>
        </p:nvSpPr>
        <p:spPr>
          <a:xfrm>
            <a:off x="285480" y="1557000"/>
            <a:ext cx="8389800" cy="4608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61000"/>
          </a:bodyPr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Subjects: 11 right-handed phobic women were recruited, with ages between 20 and 35 years. Patients were diagnosed by experienced psychologists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Our study uses as stimuli </a:t>
            </a:r>
            <a:r>
              <a:rPr b="1" lang="en-US" sz="1600" spc="-1" strike="noStrike">
                <a:solidFill>
                  <a:srgbClr val="c00000"/>
                </a:solidFill>
                <a:latin typeface="Arial"/>
              </a:rPr>
              <a:t>virtual environments 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where subjects can </a:t>
            </a:r>
            <a:r>
              <a:rPr b="1" lang="en-US" sz="1600" spc="-1" strike="noStrike">
                <a:solidFill>
                  <a:srgbClr val="c00000"/>
                </a:solidFill>
                <a:latin typeface="Arial"/>
              </a:rPr>
              <a:t>navigate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freely during shorts periods of time (about 20 seconds to avoid the possible habituation effect).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	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Previously to the fMRI, subjects did a training process to </a:t>
            </a:r>
            <a:r>
              <a:rPr b="1" lang="en-US" sz="1600" spc="-1" strike="noStrike">
                <a:solidFill>
                  <a:srgbClr val="c00000"/>
                </a:solidFill>
                <a:latin typeface="Arial"/>
              </a:rPr>
              <a:t>learn how to navigate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.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	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	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07280" indent="-107280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104" name="3 Marcador de número de diapositiva"/>
          <p:cNvSpPr/>
          <p:nvPr/>
        </p:nvSpPr>
        <p:spPr>
          <a:xfrm>
            <a:off x="34920" y="0"/>
            <a:ext cx="1008000" cy="40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9c0000"/>
                </a:solidFill>
                <a:latin typeface="Arial"/>
              </a:rPr>
              <a:t>0</a:t>
            </a:r>
            <a:fld id="{CCB507AA-C49A-4573-8F5A-4394D1FC05A7}" type="slidenum">
              <a:rPr b="0" lang="es-ES" sz="1800" spc="-1" strike="noStrike">
                <a:solidFill>
                  <a:srgbClr val="9c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5" name="5 Imagen" descr="cap22.JPG"/>
          <p:cNvPicPr/>
          <p:nvPr/>
        </p:nvPicPr>
        <p:blipFill>
          <a:blip r:embed="rId2"/>
          <a:srcRect l="36722" t="72918" r="46097" b="9375"/>
          <a:stretch/>
        </p:blipFill>
        <p:spPr>
          <a:xfrm>
            <a:off x="3203640" y="5229360"/>
            <a:ext cx="1571400" cy="1214280"/>
          </a:xfrm>
          <a:prstGeom prst="rect">
            <a:avLst/>
          </a:prstGeom>
          <a:ln w="0">
            <a:noFill/>
          </a:ln>
        </p:spPr>
      </p:pic>
      <p:sp>
        <p:nvSpPr>
          <p:cNvPr id="106" name="5 CuadroTexto"/>
          <p:cNvSpPr/>
          <p:nvPr/>
        </p:nvSpPr>
        <p:spPr>
          <a:xfrm>
            <a:off x="2771640" y="4005360"/>
            <a:ext cx="619308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04040"/>
                </a:solidFill>
                <a:latin typeface="Arial"/>
              </a:rPr>
              <a:t>The subjects are trained to search for some </a:t>
            </a:r>
            <a:r>
              <a:rPr b="1" lang="en-US" sz="1600" spc="-1" strike="noStrike">
                <a:solidFill>
                  <a:srgbClr val="c00000"/>
                </a:solidFill>
                <a:latin typeface="Arial"/>
              </a:rPr>
              <a:t>red keys</a:t>
            </a:r>
            <a:r>
              <a:rPr b="1" lang="en-US" sz="1600" spc="-1" strike="noStrike">
                <a:solidFill>
                  <a:srgbClr val="40404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404040"/>
                </a:solidFill>
                <a:latin typeface="Arial"/>
              </a:rPr>
              <a:t>that will appear and disappear during the task, that assures us </a:t>
            </a:r>
            <a:r>
              <a:rPr b="1" lang="en-US" sz="1600" spc="-1" strike="noStrike">
                <a:solidFill>
                  <a:srgbClr val="c00000"/>
                </a:solidFill>
                <a:latin typeface="Arial"/>
              </a:rPr>
              <a:t>the subject is always on movement</a:t>
            </a:r>
            <a:r>
              <a:rPr b="0" lang="en-US" sz="1600" spc="-1" strike="noStrike">
                <a:solidFill>
                  <a:srgbClr val="404040"/>
                </a:solidFill>
                <a:latin typeface="Arial"/>
              </a:rPr>
              <a:t>, so when the small animals appear they don’t just look to another side of the room and don’t move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7" name="4 Imagen" descr="cap5.JPG"/>
          <p:cNvPicPr/>
          <p:nvPr/>
        </p:nvPicPr>
        <p:blipFill>
          <a:blip r:embed="rId3"/>
          <a:stretch/>
        </p:blipFill>
        <p:spPr>
          <a:xfrm>
            <a:off x="179280" y="3500280"/>
            <a:ext cx="2521080" cy="2016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marL="990720" indent="-990720">
              <a:lnSpc>
                <a:spcPct val="80000"/>
              </a:lnSpc>
              <a:buSzPct val="154331"/>
              <a:buBlip>
                <a:blip r:embed="rId1"/>
              </a:buBlip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3600" spc="-1" strike="noStrike">
                <a:solidFill>
                  <a:srgbClr val="da0000"/>
                </a:solidFill>
                <a:latin typeface="Arial"/>
              </a:rPr>
              <a:t>ENVIRONMENTS</a:t>
            </a: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109" name=""/>
          <p:cNvSpPr txBox="1"/>
          <p:nvPr/>
        </p:nvSpPr>
        <p:spPr>
          <a:xfrm>
            <a:off x="285480" y="1557000"/>
            <a:ext cx="8389800" cy="4608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176040" indent="-1760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Different experimental conditions will be applied in a repetitive and counterbalanced way: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c00000"/>
                </a:solidFill>
                <a:latin typeface="Arial"/>
              </a:rPr>
              <a:t>A clean room without spiders or cockroaches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;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The same room, but dirty and disordered (giving the sensation that small animals can appear)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The same dirty room but with spiders and cockroaches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6040" indent="-1760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110" name="3 Marcador de número de diapositiva"/>
          <p:cNvSpPr/>
          <p:nvPr/>
        </p:nvSpPr>
        <p:spPr>
          <a:xfrm>
            <a:off x="34920" y="0"/>
            <a:ext cx="1008000" cy="40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9c0000"/>
                </a:solidFill>
                <a:latin typeface="Arial"/>
              </a:rPr>
              <a:t>0</a:t>
            </a:r>
            <a:fld id="{B0D5982A-9A4D-4CF6-A17C-70E9F99C1051}" type="slidenum">
              <a:rPr b="0" lang="es-ES" sz="1800" spc="-1" strike="noStrike">
                <a:solidFill>
                  <a:srgbClr val="9c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1" name="4 Imagen" descr="CLEMENTE_M_Fig1.tif"/>
          <p:cNvPicPr/>
          <p:nvPr/>
        </p:nvPicPr>
        <p:blipFill>
          <a:blip r:embed="rId2"/>
          <a:stretch/>
        </p:blipFill>
        <p:spPr>
          <a:xfrm>
            <a:off x="2714760" y="2286000"/>
            <a:ext cx="3238200" cy="2428920"/>
          </a:xfrm>
          <a:prstGeom prst="rect">
            <a:avLst/>
          </a:prstGeom>
          <a:ln w="0">
            <a:noFill/>
          </a:ln>
        </p:spPr>
      </p:pic>
      <p:sp>
        <p:nvSpPr>
          <p:cNvPr id="112" name="5 CuadroTexto"/>
          <p:cNvSpPr/>
          <p:nvPr/>
        </p:nvSpPr>
        <p:spPr>
          <a:xfrm>
            <a:off x="684360" y="3213000"/>
            <a:ext cx="1366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ff0000"/>
                </a:solidFill>
                <a:latin typeface="Arial"/>
              </a:rPr>
              <a:t>“</a:t>
            </a:r>
            <a:r>
              <a:rPr b="1" lang="es-ES" sz="1800" spc="-1" strike="noStrike">
                <a:solidFill>
                  <a:srgbClr val="ff0000"/>
                </a:solidFill>
                <a:latin typeface="Arial"/>
              </a:rPr>
              <a:t>CLEAN”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PlaceHolder 1"/>
          <p:cNvSpPr>
            <a:spLocks noGrp="1"/>
          </p:cNvSpPr>
          <p:nvPr>
            <p:ph type="title"/>
          </p:nvPr>
        </p:nvSpPr>
        <p:spPr>
          <a:xfrm>
            <a:off x="-360" y="188640"/>
            <a:ext cx="8675640" cy="115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marL="990720" indent="-990720">
              <a:lnSpc>
                <a:spcPct val="80000"/>
              </a:lnSpc>
              <a:buSzPct val="154331"/>
              <a:buBlip>
                <a:blip r:embed="rId1"/>
              </a:buBlip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3600" spc="-1" strike="noStrike">
                <a:solidFill>
                  <a:srgbClr val="da0000"/>
                </a:solidFill>
                <a:latin typeface="Arial"/>
              </a:rPr>
              <a:t>ENVIRONMENTS</a:t>
            </a:r>
            <a:endParaRPr b="1" lang="en-US" sz="3600" spc="-1" strike="noStrike">
              <a:solidFill>
                <a:srgbClr val="da0000"/>
              </a:solidFill>
              <a:latin typeface="Arial"/>
            </a:endParaRPr>
          </a:p>
        </p:txBody>
      </p:sp>
      <p:sp>
        <p:nvSpPr>
          <p:cNvPr id="114" name=""/>
          <p:cNvSpPr txBox="1"/>
          <p:nvPr/>
        </p:nvSpPr>
        <p:spPr>
          <a:xfrm>
            <a:off x="428760" y="1557000"/>
            <a:ext cx="8246880" cy="4608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98000"/>
          </a:bodyPr>
          <a:p>
            <a:pPr marL="172440" indent="-172440" algn="just">
              <a:spcBef>
                <a:spcPts val="4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Different experimental conditions will be applied in a repetitive and counterbalanced way: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2440" indent="-1724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A clean room without spiders or cockroaches; 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2440" indent="-1724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c00000"/>
                </a:solidFill>
                <a:latin typeface="Arial"/>
              </a:rPr>
              <a:t>The same room, but dirty and disordered</a:t>
            </a: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 (giving the sensation that small animals can appear)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2440" indent="-1724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2440" indent="-1724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2440" indent="-1724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2440" indent="-1724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2440" indent="-1724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2440" indent="-1724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2440" indent="-1724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2440" indent="-1724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2440" indent="-1724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2440" indent="-1724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2440" indent="-1724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2440" indent="-172440" algn="just">
              <a:spcBef>
                <a:spcPts val="400"/>
              </a:spcBef>
              <a:buClr>
                <a:srgbClr val="da0000"/>
              </a:buClr>
              <a:buFont typeface="Arial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4d4d4d"/>
                </a:solidFill>
                <a:latin typeface="Arial"/>
              </a:rPr>
              <a:t>The same dirty room but with spiders and cockroaches</a:t>
            </a: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  <a:p>
            <a:pPr marL="172440" indent="-172440">
              <a:spcBef>
                <a:spcPts val="400"/>
              </a:spcBef>
              <a:buClr>
                <a:srgbClr val="da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4d4d4d"/>
              </a:solidFill>
              <a:latin typeface="Arial"/>
            </a:endParaRPr>
          </a:p>
        </p:txBody>
      </p:sp>
      <p:sp>
        <p:nvSpPr>
          <p:cNvPr id="115" name="3 Marcador de número de diapositiva"/>
          <p:cNvSpPr/>
          <p:nvPr/>
        </p:nvSpPr>
        <p:spPr>
          <a:xfrm>
            <a:off x="34920" y="0"/>
            <a:ext cx="1008000" cy="40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9c0000"/>
                </a:solidFill>
                <a:latin typeface="Arial"/>
              </a:rPr>
              <a:t>0</a:t>
            </a:r>
            <a:fld id="{963716F3-4AB5-4BAE-9408-A7A55B25DE76}" type="slidenum">
              <a:rPr b="0" lang="es-ES" sz="1800" spc="-1" strike="noStrike">
                <a:solidFill>
                  <a:srgbClr val="9c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6" name="5 Imagen" descr="cap16.JPG"/>
          <p:cNvPicPr/>
          <p:nvPr/>
        </p:nvPicPr>
        <p:blipFill>
          <a:blip r:embed="rId2"/>
          <a:stretch/>
        </p:blipFill>
        <p:spPr>
          <a:xfrm>
            <a:off x="3000240" y="2786040"/>
            <a:ext cx="3714840" cy="2786040"/>
          </a:xfrm>
          <a:prstGeom prst="rect">
            <a:avLst/>
          </a:prstGeom>
          <a:ln w="0">
            <a:noFill/>
          </a:ln>
        </p:spPr>
      </p:pic>
      <p:sp>
        <p:nvSpPr>
          <p:cNvPr id="117" name="5 CuadroTexto"/>
          <p:cNvSpPr/>
          <p:nvPr/>
        </p:nvSpPr>
        <p:spPr>
          <a:xfrm>
            <a:off x="684360" y="4005360"/>
            <a:ext cx="1366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ff0000"/>
                </a:solidFill>
                <a:latin typeface="Arial"/>
              </a:rPr>
              <a:t>“</a:t>
            </a:r>
            <a:r>
              <a:rPr b="1" lang="es-ES" sz="1800" spc="-1" strike="noStrike">
                <a:solidFill>
                  <a:srgbClr val="ff0000"/>
                </a:solidFill>
                <a:latin typeface="Arial"/>
              </a:rPr>
              <a:t>DIRTY”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9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9-16T10:06:16Z</dcterms:created>
  <dc:creator>cgarrigues</dc:creator>
  <dc:description/>
  <dc:language>en-US</dc:language>
  <cp:lastModifiedBy>mclemente</cp:lastModifiedBy>
  <dcterms:modified xsi:type="dcterms:W3CDTF">2013-05-02T10:42:11Z</dcterms:modified>
  <cp:revision>189</cp:revision>
  <dc:subject/>
  <dc:title>Diapositiva 1</dc:title>
</cp:coreProperties>
</file>